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sldIdLst>
    <p:sldId id="272" r:id="rId2"/>
    <p:sldId id="260" r:id="rId3"/>
    <p:sldId id="274" r:id="rId4"/>
    <p:sldId id="259" r:id="rId5"/>
    <p:sldId id="276" r:id="rId6"/>
    <p:sldId id="266" r:id="rId7"/>
    <p:sldId id="267" r:id="rId8"/>
    <p:sldId id="264" r:id="rId9"/>
    <p:sldId id="268" r:id="rId10"/>
    <p:sldId id="269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d Habibul Mazumder" initials="MHM" lastIdx="2" clrIdx="0">
    <p:extLst>
      <p:ext uri="{19B8F6BF-5375-455C-9EA6-DF929625EA0E}">
        <p15:presenceInfo xmlns:p15="http://schemas.microsoft.com/office/powerpoint/2012/main" userId="S-1-5-21-515967899-1957994488-854245398-54947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0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EE62DA-0789-45B7-B60A-41A3F80A8F3C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6A748D-B492-43BB-8AF2-EC213F9B15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495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6A748D-B492-43BB-8AF2-EC213F9B15A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2889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228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48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145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547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00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485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592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412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845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813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950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9DB35B-73BF-4387-BE12-5064B483AA9F}" type="datetimeFigureOut">
              <a:rPr lang="en-US" smtClean="0"/>
              <a:t>8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0A656-3813-413F-AAF9-DFEC33A60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71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eg"/><Relationship Id="rId5" Type="http://schemas.openxmlformats.org/officeDocument/2006/relationships/image" Target="../media/image10.emf"/><Relationship Id="rId4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7BEAB8A-EFE8-9B7E-A856-08DBD200B1A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914" r="27681"/>
          <a:stretch/>
        </p:blipFill>
        <p:spPr>
          <a:xfrm>
            <a:off x="726469" y="2033704"/>
            <a:ext cx="2625310" cy="19202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A8AE8FE-8900-FE97-CE3A-577C8E6D377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31" t="34797" r="-5202" b="27910"/>
          <a:stretch/>
        </p:blipFill>
        <p:spPr>
          <a:xfrm>
            <a:off x="2480920" y="2536624"/>
            <a:ext cx="870859" cy="914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5CB7DBE-BED7-4E9A-6D7B-7D36FA36CC8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73" r="24448"/>
          <a:stretch/>
        </p:blipFill>
        <p:spPr>
          <a:xfrm>
            <a:off x="3672701" y="2033704"/>
            <a:ext cx="2130076" cy="18288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62BFBD3-063C-E85C-3032-802F45B37C28}"/>
              </a:ext>
            </a:extLst>
          </p:cNvPr>
          <p:cNvSpPr txBox="1"/>
          <p:nvPr/>
        </p:nvSpPr>
        <p:spPr>
          <a:xfrm>
            <a:off x="405547" y="194534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B991D1-DAAB-2D52-94EF-87068D2BCF00}"/>
              </a:ext>
            </a:extLst>
          </p:cNvPr>
          <p:cNvSpPr txBox="1"/>
          <p:nvPr/>
        </p:nvSpPr>
        <p:spPr>
          <a:xfrm>
            <a:off x="3262929" y="194534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9CA439-FCEF-5CD2-B4C8-8ECAC228AE66}"/>
              </a:ext>
            </a:extLst>
          </p:cNvPr>
          <p:cNvSpPr txBox="1"/>
          <p:nvPr/>
        </p:nvSpPr>
        <p:spPr>
          <a:xfrm>
            <a:off x="1933078" y="4581965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41843252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69704" y="284836"/>
            <a:ext cx="5545015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62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3</a:t>
            </a:r>
            <a:r>
              <a:rPr lang="en-US" sz="1662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ell surface and intracellular markers for identification for different dendritic cell subpopulations and maturation status</a:t>
            </a:r>
            <a:endParaRPr lang="en-US" sz="166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697525" y="1418404"/>
          <a:ext cx="5134091" cy="288674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94551">
                  <a:extLst>
                    <a:ext uri="{9D8B030D-6E8A-4147-A177-3AD203B41FA5}">
                      <a16:colId xmlns:a16="http://schemas.microsoft.com/office/drawing/2014/main" val="2586463559"/>
                    </a:ext>
                  </a:extLst>
                </a:gridCol>
                <a:gridCol w="3839540">
                  <a:extLst>
                    <a:ext uri="{9D8B030D-6E8A-4147-A177-3AD203B41FA5}">
                      <a16:colId xmlns:a16="http://schemas.microsoft.com/office/drawing/2014/main" val="4170444790"/>
                    </a:ext>
                  </a:extLst>
                </a:gridCol>
              </a:tblGrid>
              <a:tr h="270775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r>
                        <a:rPr lang="en-US" sz="11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4161671106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dritic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ells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808976949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b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lec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H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268977312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1</a:t>
                      </a: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103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b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581291486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2</a:t>
                      </a: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103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b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657126333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Cs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64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3602157447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0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rker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80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3772983948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tin1 marker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tin1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3408676139"/>
                  </a:ext>
                </a:extLst>
              </a:tr>
              <a:tr h="326996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7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rker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D11c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HC2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7</a:t>
                      </a:r>
                      <a:r>
                        <a:rPr lang="en-US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5527495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47596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2EB4E13-93AF-67E9-B65E-470A9A269B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652" r="25397"/>
          <a:stretch/>
        </p:blipFill>
        <p:spPr>
          <a:xfrm>
            <a:off x="654467" y="1204846"/>
            <a:ext cx="3647711" cy="2374175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19280BF5-C791-7348-DE6B-CE744911C3F5}"/>
              </a:ext>
            </a:extLst>
          </p:cNvPr>
          <p:cNvSpPr txBox="1"/>
          <p:nvPr/>
        </p:nvSpPr>
        <p:spPr>
          <a:xfrm>
            <a:off x="1516110" y="3803233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pic>
        <p:nvPicPr>
          <p:cNvPr id="9" name="Picture 8" descr="A graph of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D430C1A0-06A0-AE4F-4A84-E586ECEE97F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864" t="18608" b="40420"/>
          <a:stretch/>
        </p:blipFill>
        <p:spPr>
          <a:xfrm>
            <a:off x="4526807" y="1633866"/>
            <a:ext cx="754125" cy="718738"/>
          </a:xfrm>
          <a:prstGeom prst="rect">
            <a:avLst/>
          </a:prstGeom>
        </p:spPr>
      </p:pic>
      <p:pic>
        <p:nvPicPr>
          <p:cNvPr id="4" name="Picture 3" descr="A graph of a graph showing different levels of a certain type of substance&#10;&#10;Description automatically generated with medium confidence">
            <a:extLst>
              <a:ext uri="{FF2B5EF4-FFF2-40B4-BE49-F238E27FC236}">
                <a16:creationId xmlns:a16="http://schemas.microsoft.com/office/drawing/2014/main" id="{43654DF5-1627-F804-C713-0C8311BEA7F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445" r="13300" b="11535"/>
          <a:stretch/>
        </p:blipFill>
        <p:spPr>
          <a:xfrm>
            <a:off x="1355814" y="1204846"/>
            <a:ext cx="1757461" cy="137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3437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412EF8C-2035-7B1C-F673-80FF22A65E6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0952"/>
          <a:stretch/>
        </p:blipFill>
        <p:spPr>
          <a:xfrm>
            <a:off x="294884" y="1371843"/>
            <a:ext cx="6090432" cy="483845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46CA440-E1CA-AC39-B2F6-35C15DE90500}"/>
              </a:ext>
            </a:extLst>
          </p:cNvPr>
          <p:cNvSpPr txBox="1"/>
          <p:nvPr/>
        </p:nvSpPr>
        <p:spPr>
          <a:xfrm>
            <a:off x="1643110" y="6595981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</p:spTree>
    <p:extLst>
      <p:ext uri="{BB962C8B-B14F-4D97-AF65-F5344CB8AC3E}">
        <p14:creationId xmlns:p14="http://schemas.microsoft.com/office/powerpoint/2010/main" val="26269798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graph showing different cells&#10;&#10;Description automatically generated">
            <a:extLst>
              <a:ext uri="{FF2B5EF4-FFF2-40B4-BE49-F238E27FC236}">
                <a16:creationId xmlns:a16="http://schemas.microsoft.com/office/drawing/2014/main" id="{6F4B060D-9A88-77E9-2FAE-448E496DAAD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236"/>
          <a:stretch/>
        </p:blipFill>
        <p:spPr>
          <a:xfrm>
            <a:off x="425854" y="516933"/>
            <a:ext cx="1421606" cy="15544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68846" y="5169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27303" y="23117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4788" y="2651172"/>
            <a:ext cx="2895909" cy="193313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258857" y="228934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994257" y="5392828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EB8166F-0185-5764-2089-5397203DFC2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9522"/>
          <a:stretch/>
        </p:blipFill>
        <p:spPr>
          <a:xfrm>
            <a:off x="600068" y="2186234"/>
            <a:ext cx="2908157" cy="2882732"/>
          </a:xfrm>
          <a:prstGeom prst="rect">
            <a:avLst/>
          </a:prstGeom>
        </p:spPr>
      </p:pic>
      <p:pic>
        <p:nvPicPr>
          <p:cNvPr id="22" name="Picture 21" descr="A graph showing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FEB16347-26F3-61D7-21CB-D7D2C636E09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788"/>
          <a:stretch/>
        </p:blipFill>
        <p:spPr>
          <a:xfrm>
            <a:off x="1767946" y="588164"/>
            <a:ext cx="1344644" cy="1554480"/>
          </a:xfrm>
          <a:prstGeom prst="rect">
            <a:avLst/>
          </a:prstGeom>
        </p:spPr>
      </p:pic>
      <p:pic>
        <p:nvPicPr>
          <p:cNvPr id="24" name="Picture 23" descr="A graph of lymphocyte and hdm&#10;&#10;Description automatically generated">
            <a:extLst>
              <a:ext uri="{FF2B5EF4-FFF2-40B4-BE49-F238E27FC236}">
                <a16:creationId xmlns:a16="http://schemas.microsoft.com/office/drawing/2014/main" id="{E49971D8-402D-925F-5DB5-E1535FBD463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877"/>
          <a:stretch/>
        </p:blipFill>
        <p:spPr>
          <a:xfrm>
            <a:off x="3073090" y="588164"/>
            <a:ext cx="1344644" cy="1554480"/>
          </a:xfrm>
          <a:prstGeom prst="rect">
            <a:avLst/>
          </a:prstGeom>
        </p:spPr>
      </p:pic>
      <p:pic>
        <p:nvPicPr>
          <p:cNvPr id="26" name="Picture 25" descr="A graph of a number of eosinophil&#10;&#10;Description automatically generated">
            <a:extLst>
              <a:ext uri="{FF2B5EF4-FFF2-40B4-BE49-F238E27FC236}">
                <a16:creationId xmlns:a16="http://schemas.microsoft.com/office/drawing/2014/main" id="{4604311B-7F6A-01CD-3E31-63D6F2CE56A6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" r="11953"/>
          <a:stretch/>
        </p:blipFill>
        <p:spPr>
          <a:xfrm>
            <a:off x="4454682" y="588164"/>
            <a:ext cx="1286954" cy="1554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92988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50AEC05-1D93-DABE-6669-0C4A713A44AC}"/>
              </a:ext>
            </a:extLst>
          </p:cNvPr>
          <p:cNvSpPr txBox="1"/>
          <p:nvPr/>
        </p:nvSpPr>
        <p:spPr>
          <a:xfrm>
            <a:off x="1859306" y="4009754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9CC4707-9E52-C168-81E4-60626E9037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1678" y="1607324"/>
            <a:ext cx="2314957" cy="1920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5808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C92D6322-B590-9198-7066-F5AE034DEFE8}"/>
              </a:ext>
            </a:extLst>
          </p:cNvPr>
          <p:cNvSpPr txBox="1"/>
          <p:nvPr/>
        </p:nvSpPr>
        <p:spPr>
          <a:xfrm>
            <a:off x="1859306" y="4009754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2D0755F-4100-A3DD-4FB7-89AE3333AF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0576" t="14787" r="2151" b="67771"/>
          <a:stretch/>
        </p:blipFill>
        <p:spPr>
          <a:xfrm>
            <a:off x="4426267" y="1606418"/>
            <a:ext cx="683508" cy="48953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AF5A81C-EB86-2C06-6159-39F7ADC987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6030" y="1116764"/>
            <a:ext cx="2920237" cy="23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7362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330200" y="479994"/>
            <a:ext cx="5919212" cy="7884453"/>
            <a:chOff x="330200" y="479994"/>
            <a:chExt cx="5919212" cy="7884453"/>
          </a:xfrm>
        </p:grpSpPr>
        <p:sp>
          <p:nvSpPr>
            <p:cNvPr id="325" name="TextBox 324"/>
            <p:cNvSpPr txBox="1"/>
            <p:nvPr/>
          </p:nvSpPr>
          <p:spPr>
            <a:xfrm>
              <a:off x="1801754" y="7995115"/>
              <a:ext cx="33655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7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TextBox 325"/>
            <p:cNvSpPr txBox="1"/>
            <p:nvPr/>
          </p:nvSpPr>
          <p:spPr>
            <a:xfrm>
              <a:off x="342900" y="479994"/>
              <a:ext cx="2540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27" name="TextBox 326"/>
            <p:cNvSpPr txBox="1"/>
            <p:nvPr/>
          </p:nvSpPr>
          <p:spPr>
            <a:xfrm>
              <a:off x="330200" y="2873481"/>
              <a:ext cx="2540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328" name="TextBox 327"/>
            <p:cNvSpPr txBox="1"/>
            <p:nvPr/>
          </p:nvSpPr>
          <p:spPr>
            <a:xfrm>
              <a:off x="342900" y="6451245"/>
              <a:ext cx="2540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1500" y="502552"/>
              <a:ext cx="5671056" cy="2370929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26452" y="2873481"/>
              <a:ext cx="5516104" cy="3612282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1711" y="6512998"/>
              <a:ext cx="5727701" cy="142036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849370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63331" y="542739"/>
            <a:ext cx="4731337" cy="5628610"/>
            <a:chOff x="247576" y="1938920"/>
            <a:chExt cx="4731337" cy="562861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7576" y="2635045"/>
              <a:ext cx="4731337" cy="4932485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61414" y="1938920"/>
              <a:ext cx="450365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l Table 1: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rimer sequences for real-time PC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224586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33399" y="242652"/>
            <a:ext cx="5096711" cy="80021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 surface and intracellular markers for identification for different Lymphocyte subpopulations</a:t>
            </a:r>
          </a:p>
        </p:txBody>
      </p:sp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596900" y="1165982"/>
          <a:ext cx="4969711" cy="262141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46558">
                  <a:extLst>
                    <a:ext uri="{9D8B030D-6E8A-4147-A177-3AD203B41FA5}">
                      <a16:colId xmlns:a16="http://schemas.microsoft.com/office/drawing/2014/main" val="2586463559"/>
                    </a:ext>
                  </a:extLst>
                </a:gridCol>
                <a:gridCol w="3123153">
                  <a:extLst>
                    <a:ext uri="{9D8B030D-6E8A-4147-A177-3AD203B41FA5}">
                      <a16:colId xmlns:a16="http://schemas.microsoft.com/office/drawing/2014/main" val="4170444790"/>
                    </a:ext>
                  </a:extLst>
                </a:gridCol>
              </a:tblGrid>
              <a:tr h="327677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r>
                        <a:rPr lang="en-US" sz="12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1671106"/>
                  </a:ext>
                </a:extLst>
              </a:tr>
              <a:tr h="32767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el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220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8976949"/>
                  </a:ext>
                </a:extLst>
              </a:tr>
              <a:tr h="32767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8977312"/>
                  </a:ext>
                </a:extLst>
              </a:tr>
              <a:tr h="32767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-helper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ells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1421716"/>
                  </a:ext>
                </a:extLst>
              </a:tr>
              <a:tr h="32767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-cytotoxic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ells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0965766"/>
                  </a:ext>
                </a:extLst>
              </a:tr>
              <a:tr h="32767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memory cel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1291486"/>
                  </a:ext>
                </a:extLst>
              </a:tr>
              <a:tr h="32767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ed T cel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5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1138299"/>
                  </a:ext>
                </a:extLst>
              </a:tr>
              <a:tr h="327677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ory T cel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e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5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P3</a:t>
                      </a:r>
                      <a:r>
                        <a:rPr lang="en-US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29839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00487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74</TotalTime>
  <Words>203</Words>
  <Application>Microsoft Office PowerPoint</Application>
  <PresentationFormat>A4 Paper (210x297 mm)</PresentationFormat>
  <Paragraphs>53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rrita Majumder</dc:creator>
  <cp:lastModifiedBy>S H</cp:lastModifiedBy>
  <cp:revision>41</cp:revision>
  <dcterms:created xsi:type="dcterms:W3CDTF">2022-08-04T22:18:03Z</dcterms:created>
  <dcterms:modified xsi:type="dcterms:W3CDTF">2024-08-22T21:40:02Z</dcterms:modified>
</cp:coreProperties>
</file>